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67" autoAdjust="0"/>
    <p:restoredTop sz="94660"/>
  </p:normalViewPr>
  <p:slideViewPr>
    <p:cSldViewPr snapToGrid="0">
      <p:cViewPr varScale="1">
        <p:scale>
          <a:sx n="76" d="100"/>
          <a:sy n="76" d="100"/>
        </p:scale>
        <p:origin x="3340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319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0370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457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7412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9695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981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3181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9341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4833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074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0725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34D5E-0DD9-4732-B5F0-459B3D8D3261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67AB2-28F1-4A8B-8783-0B42B2F5517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5475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1" t="34048" r="22973" b="21508"/>
          <a:stretch/>
        </p:blipFill>
        <p:spPr>
          <a:xfrm>
            <a:off x="201541" y="2799445"/>
            <a:ext cx="2160001" cy="14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45" t="46719" r="26759" b="8837"/>
          <a:stretch/>
        </p:blipFill>
        <p:spPr>
          <a:xfrm>
            <a:off x="2414134" y="2799445"/>
            <a:ext cx="2160000" cy="14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607" t="5814" r="3197" b="49742"/>
          <a:stretch/>
        </p:blipFill>
        <p:spPr>
          <a:xfrm>
            <a:off x="4626726" y="2799445"/>
            <a:ext cx="2160000" cy="144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126742" y="2766796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2332732" y="2766795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573287" y="2766794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PC</a:t>
            </a: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5"/>
          <a:srcRect l="7877" b="6638"/>
          <a:stretch/>
        </p:blipFill>
        <p:spPr>
          <a:xfrm>
            <a:off x="543569" y="587720"/>
            <a:ext cx="1742376" cy="174300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6"/>
          <a:srcRect l="7014" b="7036"/>
          <a:stretch/>
        </p:blipFill>
        <p:spPr>
          <a:xfrm>
            <a:off x="2544307" y="607601"/>
            <a:ext cx="1710429" cy="1687959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3088128" y="2263108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0-APC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051699" y="2271252"/>
            <a:ext cx="9460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PC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-10603" y="1215045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E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6200000">
            <a:off x="2133197" y="1222376"/>
            <a:ext cx="6767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7-PE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689557" y="1995029"/>
            <a:ext cx="7008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0</a:t>
            </a:r>
            <a:r>
              <a:rPr lang="en-US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7</a:t>
            </a:r>
            <a:r>
              <a:rPr lang="en-US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de-DE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2780453" y="794946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0</a:t>
            </a:r>
            <a:r>
              <a:rPr lang="en-US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7</a:t>
            </a:r>
            <a:r>
              <a:rPr lang="de-DE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.4 ± 0.4%)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3633710" y="1145323"/>
            <a:ext cx="686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0</a:t>
            </a:r>
            <a:r>
              <a:rPr lang="de-DE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7</a:t>
            </a:r>
            <a:r>
              <a:rPr lang="en-US" sz="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</a:p>
          <a:p>
            <a:pPr algn="ctr"/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.9 ± 0.7%)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0" y="125046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4580" y="38273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4580" y="2473472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r Verbinder 21"/>
          <p:cNvCxnSpPr/>
          <p:nvPr/>
        </p:nvCxnSpPr>
        <p:spPr>
          <a:xfrm>
            <a:off x="6413848" y="4178630"/>
            <a:ext cx="32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6301991" y="3994746"/>
            <a:ext cx="5373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</a:p>
        </p:txBody>
      </p:sp>
      <p:sp>
        <p:nvSpPr>
          <p:cNvPr id="2" name="Rechteck 1"/>
          <p:cNvSpPr/>
          <p:nvPr/>
        </p:nvSpPr>
        <p:spPr>
          <a:xfrm>
            <a:off x="288836" y="4454613"/>
            <a:ext cx="6449011" cy="14691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: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lphaUcParenBoth"/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flow cytometry dot plots showing the gating strategy to isolate LM,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117</a:t>
            </a:r>
            <a:r>
              <a:rPr lang="en-US" sz="1200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90</a:t>
            </a:r>
            <a:r>
              <a:rPr lang="en-US" sz="1200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MSC, CD117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90</a:t>
            </a:r>
            <a:r>
              <a:rPr lang="en-US" sz="1200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LEPC,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117</a:t>
            </a:r>
            <a:r>
              <a:rPr lang="en-US" sz="1200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90</a:t>
            </a:r>
            <a:r>
              <a:rPr lang="en-US" sz="1200" baseline="30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 human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mbal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suspensions. Isotype controls were used to set gates.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800"/>
              </a:spcAft>
              <a:buFont typeface="+mj-lt"/>
              <a:buAutoNum type="alphaUcParenBoth"/>
            </a:pP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ase-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ast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ages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M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MSC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mary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ltures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hibiting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ypical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rphologies</a:t>
            </a: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de-D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4154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4580" y="38273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3745849"/>
              </p:ext>
            </p:extLst>
          </p:nvPr>
        </p:nvGraphicFramePr>
        <p:xfrm>
          <a:off x="207867" y="659732"/>
          <a:ext cx="5938890" cy="36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10173474" imgH="6167278" progId="Prism6.Document">
                  <p:embed/>
                </p:oleObj>
              </mc:Choice>
              <mc:Fallback>
                <p:oleObj name="Prism 6" r:id="rId3" imgW="10173474" imgH="616727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7867" y="659732"/>
                        <a:ext cx="5938890" cy="36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735273"/>
              </p:ext>
            </p:extLst>
          </p:nvPr>
        </p:nvGraphicFramePr>
        <p:xfrm>
          <a:off x="207865" y="4536731"/>
          <a:ext cx="5938887" cy="36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5" imgW="10173474" imgH="6167278" progId="Prism6.Document">
                  <p:embed/>
                </p:oleObj>
              </mc:Choice>
              <mc:Fallback>
                <p:oleObj name="Prism 6" r:id="rId5" imgW="10173474" imgH="616727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7865" y="4536731"/>
                        <a:ext cx="5938887" cy="36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hteck 6"/>
          <p:cNvSpPr/>
          <p:nvPr/>
        </p:nvSpPr>
        <p:spPr>
          <a:xfrm>
            <a:off x="381150" y="8195986"/>
            <a:ext cx="5910593" cy="10443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</a:t>
            </a:r>
            <a:endParaRPr lang="en-US" sz="1200" b="1" dirty="0" smtClean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ze distribution of LM-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V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LMSC-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V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all fractions measured by nanoparticle tracking analysis. Data presented as min to max whisker box plots (n=10/cell type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407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5</Words>
  <Application>Microsoft Office PowerPoint</Application>
  <PresentationFormat>A4-Papier (210 x 297 mm)</PresentationFormat>
  <Paragraphs>22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GraphPad Prism 6 Project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3</cp:revision>
  <dcterms:created xsi:type="dcterms:W3CDTF">2024-02-18T08:26:41Z</dcterms:created>
  <dcterms:modified xsi:type="dcterms:W3CDTF">2024-03-26T16:01:36Z</dcterms:modified>
</cp:coreProperties>
</file>